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3" r:id="rId1"/>
  </p:sldMasterIdLst>
  <p:notesMasterIdLst>
    <p:notesMasterId r:id="rId3"/>
  </p:notes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e, Hongli" initials="XH" lastIdx="8" clrIdx="0">
    <p:extLst>
      <p:ext uri="{19B8F6BF-5375-455C-9EA6-DF929625EA0E}">
        <p15:presenceInfo xmlns:p15="http://schemas.microsoft.com/office/powerpoint/2012/main" userId="S-1-5-21-2074287314-1359033266-196506527-20964" providerId="AD"/>
      </p:ext>
    </p:extLst>
  </p:cmAuthor>
  <p:cmAuthor id="2" name="Tang, Yuhong" initials="TY" lastIdx="1" clrIdx="1">
    <p:extLst>
      <p:ext uri="{19B8F6BF-5375-455C-9EA6-DF929625EA0E}">
        <p15:presenceInfo xmlns:p15="http://schemas.microsoft.com/office/powerpoint/2012/main" userId="S-1-5-21-2074287314-1359033266-196506527-11285" providerId="AD"/>
      </p:ext>
    </p:extLst>
  </p:cmAuthor>
  <p:cmAuthor id="3" name="Blancaflor, Elison" initials="BE" lastIdx="5" clrIdx="2">
    <p:extLst>
      <p:ext uri="{19B8F6BF-5375-455C-9EA6-DF929625EA0E}">
        <p15:presenceInfo xmlns:p15="http://schemas.microsoft.com/office/powerpoint/2012/main" userId="S-1-5-21-2074287314-1359033266-196506527-177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94125" autoAdjust="0"/>
  </p:normalViewPr>
  <p:slideViewPr>
    <p:cSldViewPr snapToGrid="0">
      <p:cViewPr varScale="1">
        <p:scale>
          <a:sx n="109" d="100"/>
          <a:sy n="109" d="100"/>
        </p:scale>
        <p:origin x="180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5" d="100"/>
        <a:sy n="95" d="100"/>
      </p:scale>
      <p:origin x="0" y="-13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7AF8FC-282C-4D50-A8E4-D2E2BE1ACA9E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F050B-F196-4082-B381-D05887F97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7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21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96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797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688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913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817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394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391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155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824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375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91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4" r:id="rId1"/>
    <p:sldLayoutId id="2147483725" r:id="rId2"/>
    <p:sldLayoutId id="2147483726" r:id="rId3"/>
    <p:sldLayoutId id="2147483727" r:id="rId4"/>
    <p:sldLayoutId id="2147483728" r:id="rId5"/>
    <p:sldLayoutId id="2147483729" r:id="rId6"/>
    <p:sldLayoutId id="2147483730" r:id="rId7"/>
    <p:sldLayoutId id="2147483731" r:id="rId8"/>
    <p:sldLayoutId id="2147483732" r:id="rId9"/>
    <p:sldLayoutId id="2147483733" r:id="rId10"/>
    <p:sldLayoutId id="214748373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092715" y="4971515"/>
            <a:ext cx="54975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. S1. The phenotype of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-day-old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edlings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WT, </a:t>
            </a:r>
            <a:r>
              <a:rPr lang="en-US" sz="12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pgs1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oaomt1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pgs1ccoaomt1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s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milar to </a:t>
            </a:r>
            <a:r>
              <a:rPr lang="en-US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pgs1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ngle mutants, </a:t>
            </a:r>
            <a:r>
              <a:rPr lang="en-US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pgs1ccoaomt1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ouble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tants had short </a:t>
            </a:r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oot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 early development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3048000" y="1705234"/>
            <a:ext cx="3072714" cy="3019149"/>
            <a:chOff x="2940909" y="766120"/>
            <a:chExt cx="3072714" cy="301914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71" t="7201" r="32882" b="10198"/>
            <a:stretch/>
          </p:blipFill>
          <p:spPr>
            <a:xfrm>
              <a:off x="2940909" y="766120"/>
              <a:ext cx="3072714" cy="3019149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3267598" y="1063136"/>
              <a:ext cx="3978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992153" y="1063135"/>
              <a:ext cx="4700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pgs1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77266" y="1063134"/>
              <a:ext cx="6912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oaomt1</a:t>
              </a:r>
              <a:endParaRPr lang="en-US" sz="1000" b="1" i="1" dirty="0">
                <a:solidFill>
                  <a:prstClr val="white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170289" y="986192"/>
              <a:ext cx="69121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i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pgs1</a:t>
              </a:r>
            </a:p>
            <a:p>
              <a:pPr algn="ctr"/>
              <a:r>
                <a:rPr lang="en-US" sz="1000" b="1" i="1" dirty="0">
                  <a:solidFill>
                    <a:prstClr val="white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oaomt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38577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654</TotalTime>
  <Words>44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e, Hongli</dc:creator>
  <cp:lastModifiedBy>Xie, Hongli</cp:lastModifiedBy>
  <cp:revision>518</cp:revision>
  <cp:lastPrinted>2017-10-20T14:57:19Z</cp:lastPrinted>
  <dcterms:created xsi:type="dcterms:W3CDTF">2017-05-21T20:10:06Z</dcterms:created>
  <dcterms:modified xsi:type="dcterms:W3CDTF">2019-04-11T02:56:01Z</dcterms:modified>
</cp:coreProperties>
</file>